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harp, Robert E." initials="SRE" lastIdx="0" clrIdx="0">
    <p:extLst>
      <p:ext uri="{19B8F6BF-5375-455C-9EA6-DF929625EA0E}">
        <p15:presenceInfo xmlns:p15="http://schemas.microsoft.com/office/powerpoint/2012/main" userId="S-1-5-21-201074022-649947792-1237804090-2939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 varScale="1">
        <p:scale>
          <a:sx n="88" d="100"/>
          <a:sy n="88" d="100"/>
        </p:scale>
        <p:origin x="1056" y="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DA7A6A-EF0A-40DF-B5EE-F2AC734D2092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F048F4C-FBEF-4BAC-A530-E7B4B15007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91571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F048F4C-FBEF-4BAC-A530-E7B4B15007B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59825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CC1E27-4F70-401F-8850-B4C72C9BE862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A6689-B70E-4072-AA3F-1B7517C5C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42394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CC1E27-4F70-401F-8850-B4C72C9BE862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A6689-B70E-4072-AA3F-1B7517C5C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66521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49" y="366713"/>
            <a:ext cx="1543051" cy="780097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1" y="366713"/>
            <a:ext cx="4476751" cy="780097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CC1E27-4F70-401F-8850-B4C72C9BE862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A6689-B70E-4072-AA3F-1B7517C5C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99308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CC1E27-4F70-401F-8850-B4C72C9BE862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A6689-B70E-4072-AA3F-1B7517C5C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18328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CC1E27-4F70-401F-8850-B4C72C9BE862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A6689-B70E-4072-AA3F-1B7517C5C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02943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1" y="2133601"/>
            <a:ext cx="3009900" cy="6034088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1" y="2133601"/>
            <a:ext cx="3009900" cy="6034088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CC1E27-4F70-401F-8850-B4C72C9BE862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A6689-B70E-4072-AA3F-1B7517C5C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2005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CC1E27-4F70-401F-8850-B4C72C9BE862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A6689-B70E-4072-AA3F-1B7517C5C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29543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CC1E27-4F70-401F-8850-B4C72C9BE862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A6689-B70E-4072-AA3F-1B7517C5C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3157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CC1E27-4F70-401F-8850-B4C72C9BE862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A6689-B70E-4072-AA3F-1B7517C5C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38099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CC1E27-4F70-401F-8850-B4C72C9BE862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A6689-B70E-4072-AA3F-1B7517C5C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62150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CC1E27-4F70-401F-8850-B4C72C9BE862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A6689-B70E-4072-AA3F-1B7517C5C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56695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CC1E27-4F70-401F-8850-B4C72C9BE862}" type="datetimeFigureOut">
              <a:rPr lang="en-US" smtClean="0"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7A6689-B70E-4072-AA3F-1B7517C5C4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71991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Rectangle 22"/>
          <p:cNvSpPr/>
          <p:nvPr/>
        </p:nvSpPr>
        <p:spPr>
          <a:xfrm>
            <a:off x="1524109" y="3543300"/>
            <a:ext cx="6691386" cy="1100891"/>
          </a:xfrm>
          <a:prstGeom prst="rect">
            <a:avLst/>
          </a:prstGeom>
        </p:spPr>
        <p:txBody>
          <a:bodyPr wrap="square" lIns="61544" tIns="30772" rIns="61544" bIns="30772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lnSpc>
                <a:spcPct val="150000"/>
              </a:lnSpc>
            </a:pPr>
            <a:r>
              <a:rPr lang="en-US" sz="900" b="1" dirty="0">
                <a:latin typeface="Times New Roman" pitchFamily="18" charset="0"/>
                <a:cs typeface="Times New Roman" pitchFamily="18" charset="0"/>
              </a:rPr>
              <a:t>Supplementary Figure S2. </a:t>
            </a:r>
            <a:r>
              <a:rPr lang="en-US" sz="900" dirty="0">
                <a:latin typeface="Times New Roman" pitchFamily="18" charset="0"/>
                <a:cs typeface="Times New Roman" pitchFamily="18" charset="0"/>
              </a:rPr>
              <a:t>Cytosolic ROS in the apical 5 mm of the primary root of CK44 oxalate oxidase transgenic (Trans) and wild-type lines at 48 h after transplanting to well-watered (WW) or water-stressed (WS; -1.6 MPa) conditions. Roots were stained using the fluorescent ROS indicator carboxy-H2DCFDA (membrane permeable), and imaged using a stereomicroscope. The numbers on the images indicate normalized pixel intensities (± SE; n = 3 roots) of a 0.9 mm2 area of the root (2.5 mm long, 0.36 mm wide), as illustrated in the Trans WS image. Experiments were repeated with similar results, and representative images are shown. </a:t>
            </a:r>
          </a:p>
        </p:txBody>
      </p:sp>
      <p:grpSp>
        <p:nvGrpSpPr>
          <p:cNvPr id="8" name="Group 7"/>
          <p:cNvGrpSpPr/>
          <p:nvPr/>
        </p:nvGrpSpPr>
        <p:grpSpPr>
          <a:xfrm>
            <a:off x="604658" y="1745850"/>
            <a:ext cx="7612460" cy="1531468"/>
            <a:chOff x="604658" y="1745850"/>
            <a:chExt cx="7612460" cy="1531468"/>
          </a:xfrm>
        </p:grpSpPr>
        <p:grpSp>
          <p:nvGrpSpPr>
            <p:cNvPr id="2" name="Group 1"/>
            <p:cNvGrpSpPr/>
            <p:nvPr/>
          </p:nvGrpSpPr>
          <p:grpSpPr>
            <a:xfrm>
              <a:off x="604658" y="1745850"/>
              <a:ext cx="7612460" cy="1531468"/>
              <a:chOff x="757059" y="1776514"/>
              <a:chExt cx="7612460" cy="1531468"/>
            </a:xfrm>
          </p:grpSpPr>
          <p:grpSp>
            <p:nvGrpSpPr>
              <p:cNvPr id="3" name="Group 2"/>
              <p:cNvGrpSpPr/>
              <p:nvPr/>
            </p:nvGrpSpPr>
            <p:grpSpPr>
              <a:xfrm>
                <a:off x="757059" y="1776514"/>
                <a:ext cx="7413519" cy="1186422"/>
                <a:chOff x="500780" y="3435481"/>
                <a:chExt cx="6064016" cy="1581895"/>
              </a:xfrm>
            </p:grpSpPr>
            <p:sp>
              <p:nvSpPr>
                <p:cNvPr id="13" name="TextBox 12"/>
                <p:cNvSpPr txBox="1"/>
                <p:nvPr/>
              </p:nvSpPr>
              <p:spPr>
                <a:xfrm>
                  <a:off x="5541959" y="3952486"/>
                  <a:ext cx="1022837" cy="41036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400" dirty="0">
                      <a:latin typeface="Times New Roman" pitchFamily="18" charset="0"/>
                      <a:cs typeface="Times New Roman" pitchFamily="18" charset="0"/>
                    </a:rPr>
                    <a:t>Trans WS</a:t>
                  </a:r>
                </a:p>
              </p:txBody>
            </p:sp>
            <p:sp>
              <p:nvSpPr>
                <p:cNvPr id="11" name="TextBox 10"/>
                <p:cNvSpPr txBox="1"/>
                <p:nvPr/>
              </p:nvSpPr>
              <p:spPr>
                <a:xfrm>
                  <a:off x="1280162" y="3952486"/>
                  <a:ext cx="1310645" cy="41036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400" dirty="0" err="1">
                      <a:latin typeface="Times New Roman" pitchFamily="18" charset="0"/>
                      <a:cs typeface="Times New Roman" pitchFamily="18" charset="0"/>
                    </a:rPr>
                    <a:t>Wildtype</a:t>
                  </a:r>
                  <a:r>
                    <a:rPr lang="en-US" sz="1400" dirty="0">
                      <a:latin typeface="Times New Roman" pitchFamily="18" charset="0"/>
                      <a:cs typeface="Times New Roman" pitchFamily="18" charset="0"/>
                    </a:rPr>
                    <a:t> WW</a:t>
                  </a:r>
                </a:p>
              </p:txBody>
            </p:sp>
            <p:sp>
              <p:nvSpPr>
                <p:cNvPr id="12" name="TextBox 11"/>
                <p:cNvSpPr txBox="1"/>
                <p:nvPr/>
              </p:nvSpPr>
              <p:spPr>
                <a:xfrm>
                  <a:off x="4149365" y="3952486"/>
                  <a:ext cx="1082617" cy="41036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400" dirty="0">
                      <a:latin typeface="Times New Roman" pitchFamily="18" charset="0"/>
                      <a:cs typeface="Times New Roman" pitchFamily="18" charset="0"/>
                    </a:rPr>
                    <a:t>Trans WW</a:t>
                  </a:r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>
                  <a:off x="2675896" y="3952486"/>
                  <a:ext cx="1226463" cy="41036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400" dirty="0" err="1">
                      <a:latin typeface="Times New Roman" pitchFamily="18" charset="0"/>
                      <a:cs typeface="Times New Roman" pitchFamily="18" charset="0"/>
                    </a:rPr>
                    <a:t>Wildtype</a:t>
                  </a:r>
                  <a:r>
                    <a:rPr lang="en-US" sz="1400" dirty="0">
                      <a:latin typeface="Times New Roman" pitchFamily="18" charset="0"/>
                      <a:cs typeface="Times New Roman" pitchFamily="18" charset="0"/>
                    </a:rPr>
                    <a:t> WS</a:t>
                  </a:r>
                </a:p>
              </p:txBody>
            </p:sp>
            <p:sp>
              <p:nvSpPr>
                <p:cNvPr id="24" name="TextBox 23"/>
                <p:cNvSpPr txBox="1"/>
                <p:nvPr/>
              </p:nvSpPr>
              <p:spPr>
                <a:xfrm>
                  <a:off x="646876" y="4607007"/>
                  <a:ext cx="516978" cy="410369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K44</a:t>
                  </a:r>
                </a:p>
              </p:txBody>
            </p:sp>
            <p:sp>
              <p:nvSpPr>
                <p:cNvPr id="21" name="Rectangle 20"/>
                <p:cNvSpPr/>
                <p:nvPr/>
              </p:nvSpPr>
              <p:spPr>
                <a:xfrm>
                  <a:off x="500780" y="3435481"/>
                  <a:ext cx="2302684" cy="41036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4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upporting Information Figure S2</a:t>
                  </a:r>
                  <a:endParaRPr lang="en-US" sz="1400" dirty="0"/>
                </a:p>
              </p:txBody>
            </p:sp>
          </p:grpSp>
          <p:grpSp>
            <p:nvGrpSpPr>
              <p:cNvPr id="39" name="Group 38"/>
              <p:cNvGrpSpPr/>
              <p:nvPr/>
            </p:nvGrpSpPr>
            <p:grpSpPr>
              <a:xfrm>
                <a:off x="5079275" y="2439641"/>
                <a:ext cx="1600214" cy="822962"/>
                <a:chOff x="4571999" y="3200399"/>
                <a:chExt cx="1600214" cy="822962"/>
              </a:xfrm>
            </p:grpSpPr>
            <p:pic>
              <p:nvPicPr>
                <p:cNvPr id="40" name="Picture 9" descr="\\pltsci-sharplab\lab folders$\Priya\Sharp Lab\OO\Cytosolic ROS\For Fig\3or4WW_Trans_1.6_5.154.tif"/>
                <p:cNvPicPr>
                  <a:picLocks noChangeArrowheads="1"/>
                </p:cNvPicPr>
                <p:nvPr/>
              </p:nvPicPr>
              <p:blipFill rotWithShape="1"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/>
              </p:blipFill>
              <p:spPr bwMode="auto">
                <a:xfrm rot="5400000">
                  <a:off x="4960627" y="2811773"/>
                  <a:ext cx="822960" cy="1600213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1" name="Picture 12" descr="\\pltsci-sharplab\lab folders$\Priya\Sharp Lab\OO\Cytosolic ROS\For Fig\WS_Trans_1.6_5.154.tif"/>
                <p:cNvPicPr>
                  <a:picLocks noChangeAspect="1" noChangeArrowheads="1"/>
                </p:cNvPicPr>
                <p:nvPr/>
              </p:nvPicPr>
              <p:blipFill rotWithShape="1"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/>
              </p:blipFill>
              <p:spPr bwMode="auto">
                <a:xfrm rot="5400000">
                  <a:off x="4624764" y="3147635"/>
                  <a:ext cx="212657" cy="318185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2" name="Picture 12" descr="\\pltsci-sharplab\lab folders$\Priya\Sharp Lab\OO\Cytosolic ROS\For Fig\WS_Trans_1.6_5.154.tif"/>
                <p:cNvPicPr>
                  <a:picLocks noChangeAspect="1" noChangeArrowheads="1"/>
                </p:cNvPicPr>
                <p:nvPr/>
              </p:nvPicPr>
              <p:blipFill rotWithShape="1"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/>
              </p:blipFill>
              <p:spPr bwMode="auto">
                <a:xfrm rot="5400000">
                  <a:off x="4584922" y="3736118"/>
                  <a:ext cx="274320" cy="300165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</p:grpSp>
          <p:grpSp>
            <p:nvGrpSpPr>
              <p:cNvPr id="43" name="Group 42"/>
              <p:cNvGrpSpPr/>
              <p:nvPr/>
            </p:nvGrpSpPr>
            <p:grpSpPr>
              <a:xfrm>
                <a:off x="3367040" y="2439643"/>
                <a:ext cx="1597787" cy="822961"/>
                <a:chOff x="3543286" y="3487951"/>
                <a:chExt cx="1597787" cy="822961"/>
              </a:xfrm>
            </p:grpSpPr>
            <p:pic>
              <p:nvPicPr>
                <p:cNvPr id="44" name="Picture 12" descr="\\pltsci-sharplab\lab folders$\Priya\Sharp Lab\OO\Cytosolic ROS\For Fig\WS_Trans_1.6_5.154.tif"/>
                <p:cNvPicPr>
                  <a:picLocks noChangeAspect="1" noChangeArrowheads="1"/>
                </p:cNvPicPr>
                <p:nvPr/>
              </p:nvPicPr>
              <p:blipFill rotWithShape="1"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/>
              </p:blipFill>
              <p:spPr bwMode="auto">
                <a:xfrm rot="5400000">
                  <a:off x="3592969" y="4055795"/>
                  <a:ext cx="205434" cy="304799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5" name="Picture 11" descr="\\pltsci-sharplab\lab folders$\Priya\Sharp Lab\OO\Cytosolic ROS\For Fig\4WS_Null_1.6_5.154.tif"/>
                <p:cNvPicPr>
                  <a:picLocks noChangeArrowheads="1"/>
                </p:cNvPicPr>
                <p:nvPr/>
              </p:nvPicPr>
              <p:blipFill rotWithShape="1"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/>
              </p:blipFill>
              <p:spPr bwMode="auto">
                <a:xfrm rot="5400000">
                  <a:off x="3930700" y="3100538"/>
                  <a:ext cx="822960" cy="1597786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</p:grpSp>
          <p:grpSp>
            <p:nvGrpSpPr>
              <p:cNvPr id="46" name="Group 45"/>
              <p:cNvGrpSpPr/>
              <p:nvPr/>
            </p:nvGrpSpPr>
            <p:grpSpPr>
              <a:xfrm>
                <a:off x="1658407" y="2442486"/>
                <a:ext cx="1635670" cy="865496"/>
                <a:chOff x="1869530" y="4919537"/>
                <a:chExt cx="1635670" cy="865496"/>
              </a:xfrm>
            </p:grpSpPr>
            <p:pic>
              <p:nvPicPr>
                <p:cNvPr id="47" name="Picture 12" descr="\\pltsci-sharplab\lab folders$\Priya\Sharp Lab\OO\Cytosolic ROS\For Fig\WS_Trans_1.6_5.154.tif"/>
                <p:cNvPicPr>
                  <a:picLocks noChangeAspect="1" noChangeArrowheads="1"/>
                </p:cNvPicPr>
                <p:nvPr/>
              </p:nvPicPr>
              <p:blipFill rotWithShape="1"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/>
              </p:blipFill>
              <p:spPr bwMode="auto">
                <a:xfrm rot="5400000">
                  <a:off x="1893576" y="4914028"/>
                  <a:ext cx="126178" cy="138066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8" name="Picture 10" descr="\\pltsci-sharplab\lab folders$\Priya\Sharp Lab\OO\Cytosolic ROS\For Fig\WW2_Null_1.6_5.154.tif"/>
                <p:cNvPicPr>
                  <a:picLocks noChangeAspect="1" noChangeArrowheads="1"/>
                </p:cNvPicPr>
                <p:nvPr/>
              </p:nvPicPr>
              <p:blipFill rotWithShape="1">
                <a:blip r:embed="rId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/>
              </p:blipFill>
              <p:spPr bwMode="auto">
                <a:xfrm rot="5400000">
                  <a:off x="2276856" y="4531995"/>
                  <a:ext cx="825129" cy="1600214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49" name="TextBox 48"/>
                <p:cNvSpPr txBox="1"/>
                <p:nvPr/>
              </p:nvSpPr>
              <p:spPr>
                <a:xfrm>
                  <a:off x="1869530" y="5455367"/>
                  <a:ext cx="74212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solidFill>
                        <a:schemeClr val="bg2"/>
                      </a:solidFill>
                      <a:latin typeface="Times New Roman" pitchFamily="18" charset="0"/>
                      <a:cs typeface="Times New Roman" pitchFamily="18" charset="0"/>
                    </a:rPr>
                    <a:t>1 mm</a:t>
                  </a:r>
                </a:p>
              </p:txBody>
            </p:sp>
            <p:sp>
              <p:nvSpPr>
                <p:cNvPr id="50" name="TextBox 49"/>
                <p:cNvSpPr txBox="1"/>
                <p:nvPr/>
              </p:nvSpPr>
              <p:spPr>
                <a:xfrm>
                  <a:off x="2732209" y="5477256"/>
                  <a:ext cx="77299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itchFamily="18" charset="0"/>
                    </a:rPr>
                    <a:t>12 ± 0.4</a:t>
                  </a:r>
                </a:p>
              </p:txBody>
            </p:sp>
            <p:cxnSp>
              <p:nvCxnSpPr>
                <p:cNvPr id="51" name="Straight Connector 50"/>
                <p:cNvCxnSpPr/>
                <p:nvPr/>
              </p:nvCxnSpPr>
              <p:spPr>
                <a:xfrm>
                  <a:off x="1990733" y="5692714"/>
                  <a:ext cx="320040" cy="0"/>
                </a:xfrm>
                <a:prstGeom prst="line">
                  <a:avLst/>
                </a:prstGeom>
                <a:ln w="127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2" name="Group 51"/>
              <p:cNvGrpSpPr/>
              <p:nvPr/>
            </p:nvGrpSpPr>
            <p:grpSpPr>
              <a:xfrm>
                <a:off x="6767717" y="2439641"/>
                <a:ext cx="1601802" cy="858816"/>
                <a:chOff x="7086611" y="4581793"/>
                <a:chExt cx="1601802" cy="858816"/>
              </a:xfrm>
            </p:grpSpPr>
            <p:grpSp>
              <p:nvGrpSpPr>
                <p:cNvPr id="53" name="Group 52"/>
                <p:cNvGrpSpPr/>
                <p:nvPr/>
              </p:nvGrpSpPr>
              <p:grpSpPr>
                <a:xfrm>
                  <a:off x="7086611" y="4581793"/>
                  <a:ext cx="1600179" cy="822960"/>
                  <a:chOff x="6629398" y="3505200"/>
                  <a:chExt cx="1600179" cy="822960"/>
                </a:xfrm>
              </p:grpSpPr>
              <p:pic>
                <p:nvPicPr>
                  <p:cNvPr id="56" name="Picture 12" descr="\\pltsci-sharplab\lab folders$\Priya\Sharp Lab\OO\Cytosolic ROS\For Fig\WS_Trans_1.6_5.154.tif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10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/>
                </p:blipFill>
                <p:spPr bwMode="auto">
                  <a:xfrm rot="5400000">
                    <a:off x="6629397" y="3505201"/>
                    <a:ext cx="304801" cy="304799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57" name="Picture 12" descr="\\pltsci-sharplab\lab folders$\Priya\Sharp Lab\OO\Cytosolic ROS\For Fig\WS_Trans_1.6_5.154.tif"/>
                  <p:cNvPicPr>
                    <a:picLocks noChangeArrowheads="1"/>
                  </p:cNvPicPr>
                  <p:nvPr/>
                </p:nvPicPr>
                <p:blipFill rotWithShape="1">
                  <a:blip r:embed="rId11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/>
                </p:blipFill>
                <p:spPr bwMode="auto">
                  <a:xfrm rot="5400000">
                    <a:off x="7018008" y="3116591"/>
                    <a:ext cx="822960" cy="1600178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</p:grpSp>
            <p:sp>
              <p:nvSpPr>
                <p:cNvPr id="54" name="Rectangle 53"/>
                <p:cNvSpPr/>
                <p:nvPr/>
              </p:nvSpPr>
              <p:spPr>
                <a:xfrm rot="423649">
                  <a:off x="7311747" y="4936726"/>
                  <a:ext cx="822960" cy="118230"/>
                </a:xfrm>
                <a:prstGeom prst="rect">
                  <a:avLst/>
                </a:prstGeom>
                <a:noFill/>
                <a:ln w="12700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5" name="TextBox 54"/>
                <p:cNvSpPr txBox="1"/>
                <p:nvPr/>
              </p:nvSpPr>
              <p:spPr>
                <a:xfrm>
                  <a:off x="7911173" y="5132832"/>
                  <a:ext cx="77724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rPr>
                    <a:t>15 ± 0.5</a:t>
                  </a:r>
                </a:p>
              </p:txBody>
            </p:sp>
          </p:grpSp>
        </p:grpSp>
        <p:sp>
          <p:nvSpPr>
            <p:cNvPr id="58" name="TextBox 57"/>
            <p:cNvSpPr txBox="1"/>
            <p:nvPr/>
          </p:nvSpPr>
          <p:spPr>
            <a:xfrm>
              <a:off x="5772166" y="2960016"/>
              <a:ext cx="77416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11 ± 0.9</a:t>
              </a:r>
              <a:r>
                <a:rPr lang="en-US" sz="1400" baseline="300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en-US" sz="1400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4050807" y="2965803"/>
              <a:ext cx="77896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itchFamily="18" charset="0"/>
                </a:rPr>
                <a:t>16 ± 3.0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2245188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4</TotalTime>
  <Words>149</Words>
  <Application>Microsoft Office PowerPoint</Application>
  <PresentationFormat>On-screen Show (4:3)</PresentationFormat>
  <Paragraphs>1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oothuluru, Priyamvada (MU-Student)</dc:creator>
  <cp:lastModifiedBy>Voothuluru</cp:lastModifiedBy>
  <cp:revision>23</cp:revision>
  <dcterms:created xsi:type="dcterms:W3CDTF">2014-01-13T20:26:51Z</dcterms:created>
  <dcterms:modified xsi:type="dcterms:W3CDTF">2020-03-30T22:25:42Z</dcterms:modified>
</cp:coreProperties>
</file>